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55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G:\NDB&#12458;&#12540;&#12503;&#12531;&#12487;&#12540;&#12479;&#12398;&#20998;&#26512;\&#21407;&#31295;_%20&#21307;&#30274;&#36027;&#35036;&#21161;&#25919;&#31574;&#12392;&#12501;&#12483;&#21270;&#29289;&#27927;&#21475;\&#12464;&#12521;&#12501;&#20316;&#25104;&#29992;_bmcpb_revision_1130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収入!$E$1</c:f>
              <c:strCache>
                <c:ptCount val="1"/>
                <c:pt idx="0">
                  <c:v>2016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numRef>
              <c:f>収入!$D$2:$D$48</c:f>
              <c:numCache>
                <c:formatCode>General</c:formatCode>
                <c:ptCount val="47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</c:numCache>
            </c:numRef>
          </c:cat>
          <c:val>
            <c:numRef>
              <c:f>収入!$E$2:$E$48</c:f>
              <c:numCache>
                <c:formatCode>\ ###,###,###,###,##0;"-"###,###,###,###,##0</c:formatCode>
                <c:ptCount val="47"/>
                <c:pt idx="0">
                  <c:v>2615.3914139243639</c:v>
                </c:pt>
                <c:pt idx="1">
                  <c:v>2570.3224659249922</c:v>
                </c:pt>
                <c:pt idx="2">
                  <c:v>2683.8192324405577</c:v>
                </c:pt>
                <c:pt idx="3">
                  <c:v>2890.4648687621238</c:v>
                </c:pt>
                <c:pt idx="4">
                  <c:v>2559.5579745020332</c:v>
                </c:pt>
                <c:pt idx="5">
                  <c:v>2698.7024631010977</c:v>
                </c:pt>
                <c:pt idx="6">
                  <c:v>2902.4158757549608</c:v>
                </c:pt>
                <c:pt idx="7">
                  <c:v>3099.4608533390251</c:v>
                </c:pt>
                <c:pt idx="8">
                  <c:v>3369.3871717245702</c:v>
                </c:pt>
                <c:pt idx="9">
                  <c:v>3159.5741760755395</c:v>
                </c:pt>
                <c:pt idx="10">
                  <c:v>2960.7471312224866</c:v>
                </c:pt>
                <c:pt idx="11">
                  <c:v>2993.0877323807581</c:v>
                </c:pt>
                <c:pt idx="12">
                  <c:v>5400.2740177086844</c:v>
                </c:pt>
                <c:pt idx="13">
                  <c:v>3173.3501346819908</c:v>
                </c:pt>
                <c:pt idx="14">
                  <c:v>2817.4783469535687</c:v>
                </c:pt>
                <c:pt idx="15">
                  <c:v>3160.7380947220931</c:v>
                </c:pt>
                <c:pt idx="16">
                  <c:v>2890.1430038631374</c:v>
                </c:pt>
                <c:pt idx="17">
                  <c:v>3149.9199269948917</c:v>
                </c:pt>
                <c:pt idx="18">
                  <c:v>2865.6575566343822</c:v>
                </c:pt>
                <c:pt idx="19">
                  <c:v>2848.2992627145231</c:v>
                </c:pt>
                <c:pt idx="20">
                  <c:v>2774.2043017559963</c:v>
                </c:pt>
                <c:pt idx="21">
                  <c:v>3321.9414003646748</c:v>
                </c:pt>
                <c:pt idx="22">
                  <c:v>3629.532430164249</c:v>
                </c:pt>
                <c:pt idx="23">
                  <c:v>3046.1964035667911</c:v>
                </c:pt>
                <c:pt idx="24">
                  <c:v>3200.6844418649093</c:v>
                </c:pt>
                <c:pt idx="25">
                  <c:v>2938.689979730163</c:v>
                </c:pt>
                <c:pt idx="26">
                  <c:v>3041.1828480957624</c:v>
                </c:pt>
                <c:pt idx="27">
                  <c:v>2882.814250747695</c:v>
                </c:pt>
                <c:pt idx="28">
                  <c:v>2501.5523634189303</c:v>
                </c:pt>
                <c:pt idx="29">
                  <c:v>2924.6310060764372</c:v>
                </c:pt>
                <c:pt idx="30">
                  <c:v>2370.9305877932557</c:v>
                </c:pt>
                <c:pt idx="31">
                  <c:v>2606.1384855561205</c:v>
                </c:pt>
                <c:pt idx="32">
                  <c:v>2723.2297634461615</c:v>
                </c:pt>
                <c:pt idx="33">
                  <c:v>3065.6556756520527</c:v>
                </c:pt>
                <c:pt idx="34">
                  <c:v>3096.0463281698221</c:v>
                </c:pt>
                <c:pt idx="35">
                  <c:v>2950.8408693426609</c:v>
                </c:pt>
                <c:pt idx="36">
                  <c:v>2935.8263905533618</c:v>
                </c:pt>
                <c:pt idx="37">
                  <c:v>2598.3508786731386</c:v>
                </c:pt>
                <c:pt idx="38">
                  <c:v>2573.1456977524786</c:v>
                </c:pt>
                <c:pt idx="39">
                  <c:v>2793.0822428914184</c:v>
                </c:pt>
                <c:pt idx="40">
                  <c:v>2528.8730022489976</c:v>
                </c:pt>
                <c:pt idx="41">
                  <c:v>2522.7803498996191</c:v>
                </c:pt>
                <c:pt idx="42">
                  <c:v>2533.2911729876187</c:v>
                </c:pt>
                <c:pt idx="43">
                  <c:v>2585.420365409173</c:v>
                </c:pt>
                <c:pt idx="44">
                  <c:v>2387.6010221033034</c:v>
                </c:pt>
                <c:pt idx="45">
                  <c:v>2398.1828098650608</c:v>
                </c:pt>
                <c:pt idx="46">
                  <c:v>2313.10644198930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D66-40B0-95FD-693A50A3A9BF}"/>
            </c:ext>
          </c:extLst>
        </c:ser>
        <c:ser>
          <c:idx val="1"/>
          <c:order val="1"/>
          <c:tx>
            <c:strRef>
              <c:f>収入!$F$1</c:f>
              <c:strCache>
                <c:ptCount val="1"/>
                <c:pt idx="0">
                  <c:v>2018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収入!$D$2:$D$48</c:f>
              <c:numCache>
                <c:formatCode>General</c:formatCode>
                <c:ptCount val="47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</c:numCache>
            </c:numRef>
          </c:cat>
          <c:val>
            <c:numRef>
              <c:f>収入!$F$2:$F$48</c:f>
              <c:numCache>
                <c:formatCode>General</c:formatCode>
                <c:ptCount val="47"/>
                <c:pt idx="0">
                  <c:v>2742.2188999999998</c:v>
                </c:pt>
                <c:pt idx="1">
                  <c:v>2507.4137000000001</c:v>
                </c:pt>
                <c:pt idx="2">
                  <c:v>2841.0700999999999</c:v>
                </c:pt>
                <c:pt idx="3">
                  <c:v>2944.8764000000001</c:v>
                </c:pt>
                <c:pt idx="4">
                  <c:v>2697.1608999999999</c:v>
                </c:pt>
                <c:pt idx="5">
                  <c:v>2896.5628999999999</c:v>
                </c:pt>
                <c:pt idx="6">
                  <c:v>2942.7718</c:v>
                </c:pt>
                <c:pt idx="7">
                  <c:v>3327.3051</c:v>
                </c:pt>
                <c:pt idx="8">
                  <c:v>3479.1938</c:v>
                </c:pt>
                <c:pt idx="9">
                  <c:v>3282.8784999999998</c:v>
                </c:pt>
                <c:pt idx="10">
                  <c:v>3046.8393999999998</c:v>
                </c:pt>
                <c:pt idx="11">
                  <c:v>3115.8335999999999</c:v>
                </c:pt>
                <c:pt idx="12">
                  <c:v>5414.8311000000003</c:v>
                </c:pt>
                <c:pt idx="13">
                  <c:v>3267.8298</c:v>
                </c:pt>
                <c:pt idx="14">
                  <c:v>2915.9097999999999</c:v>
                </c:pt>
                <c:pt idx="15">
                  <c:v>3398.1408999999999</c:v>
                </c:pt>
                <c:pt idx="16">
                  <c:v>3022.6947</c:v>
                </c:pt>
                <c:pt idx="17">
                  <c:v>3279.8029999999999</c:v>
                </c:pt>
                <c:pt idx="18">
                  <c:v>3159.7408999999998</c:v>
                </c:pt>
                <c:pt idx="19">
                  <c:v>3009.7635</c:v>
                </c:pt>
                <c:pt idx="20">
                  <c:v>2919.0055000000002</c:v>
                </c:pt>
                <c:pt idx="21">
                  <c:v>3431.6253000000002</c:v>
                </c:pt>
                <c:pt idx="22">
                  <c:v>3727.8130000000001</c:v>
                </c:pt>
                <c:pt idx="23">
                  <c:v>3120.9409999999998</c:v>
                </c:pt>
                <c:pt idx="24">
                  <c:v>3318.4681999999998</c:v>
                </c:pt>
                <c:pt idx="25">
                  <c:v>2982.6712000000002</c:v>
                </c:pt>
                <c:pt idx="26">
                  <c:v>3189.5068999999999</c:v>
                </c:pt>
                <c:pt idx="27">
                  <c:v>2967.7492999999999</c:v>
                </c:pt>
                <c:pt idx="28">
                  <c:v>2631.5064000000002</c:v>
                </c:pt>
                <c:pt idx="29">
                  <c:v>2912.7447999999999</c:v>
                </c:pt>
                <c:pt idx="30">
                  <c:v>2515.3310999999999</c:v>
                </c:pt>
                <c:pt idx="31">
                  <c:v>2667.2548999999999</c:v>
                </c:pt>
                <c:pt idx="32">
                  <c:v>2769.0599000000002</c:v>
                </c:pt>
                <c:pt idx="33">
                  <c:v>3109.1331</c:v>
                </c:pt>
                <c:pt idx="34">
                  <c:v>3198.54</c:v>
                </c:pt>
                <c:pt idx="35">
                  <c:v>3092.3528999999999</c:v>
                </c:pt>
                <c:pt idx="36">
                  <c:v>3013.4911999999999</c:v>
                </c:pt>
                <c:pt idx="37">
                  <c:v>2658.0154000000002</c:v>
                </c:pt>
                <c:pt idx="38">
                  <c:v>2643.8157000000001</c:v>
                </c:pt>
                <c:pt idx="39">
                  <c:v>2885.2804999999998</c:v>
                </c:pt>
                <c:pt idx="40">
                  <c:v>2752.5970000000002</c:v>
                </c:pt>
                <c:pt idx="41">
                  <c:v>2629.1779999999999</c:v>
                </c:pt>
                <c:pt idx="42">
                  <c:v>2667.4459000000002</c:v>
                </c:pt>
                <c:pt idx="43">
                  <c:v>2713.6653999999999</c:v>
                </c:pt>
                <c:pt idx="44">
                  <c:v>2467.5702000000001</c:v>
                </c:pt>
                <c:pt idx="45">
                  <c:v>2508.5479999999998</c:v>
                </c:pt>
                <c:pt idx="46">
                  <c:v>2390.9686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D66-40B0-95FD-693A50A3A9B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58107743"/>
        <c:axId val="948877631"/>
      </c:barChart>
      <c:catAx>
        <c:axId val="75810774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948877631"/>
        <c:crosses val="autoZero"/>
        <c:auto val="1"/>
        <c:lblAlgn val="ctr"/>
        <c:lblOffset val="100"/>
        <c:noMultiLvlLbl val="0"/>
      </c:catAx>
      <c:valAx>
        <c:axId val="948877631"/>
        <c:scaling>
          <c:orientation val="minMax"/>
        </c:scaling>
        <c:delete val="0"/>
        <c:axPos val="l"/>
        <c:numFmt formatCode="\ ###,###,###,###,##0;&quot;-&quot;###,###,###,###,##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758107743"/>
        <c:crosses val="autoZero"/>
        <c:crossBetween val="between"/>
      </c:valAx>
      <c:spPr>
        <a:noFill/>
        <a:ln w="25400">
          <a:noFill/>
        </a:ln>
        <a:effectLst/>
      </c:spPr>
    </c:plotArea>
    <c:legend>
      <c:legendPos val="b"/>
      <c:layout>
        <c:manualLayout>
          <c:xMode val="edge"/>
          <c:yMode val="edge"/>
          <c:x val="0.83528029494043865"/>
          <c:y val="0.17529068424261121"/>
          <c:w val="0.13283090159681238"/>
          <c:h val="5.570584737009198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60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343DC77-A271-59F5-D55A-34C37773D89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1827E775-A75E-72C3-8B29-D00DB28C30C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A3334CE-66D1-01BC-0892-9FDC7756E5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8F20D4A-A2B7-4470-09C6-6E85CF6E85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AD0B358-E515-6038-8FE4-CEE4867463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97976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D6F22B9-3D77-2A8E-3B09-6786753F0A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F10BF24-9BE9-32E4-7A83-A0DC2398BB1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3299C77-A68E-BBA4-6FAE-7EB6DB5F7B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5E6ECA1-0675-CEA1-77A3-B6B183A1B1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D217A69-7625-BA8D-A570-B257F8D649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55395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105D4B15-19F5-1B26-7E9A-BFCFB6EE434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776D627-F637-0A82-C18D-0CAA2B9F9B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4212BFC-389F-91B6-5510-932A6B27A1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AF69F6F-956E-B0C0-4E41-0B3D70EF4F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C9DA32D-9D7A-7090-5B44-486932F203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33604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34A640D-60D2-0DAB-326C-DAD962557E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9F33413-7D16-8BD1-159F-5783A08AE81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B9B6378-0983-38D7-C3F3-391E54065C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4360BA4-C8B4-E86D-DDBA-C96EAF3CC8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E5B040C-451A-3FDC-9815-78C46D36C1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01746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B812DA3-EAC7-0466-D0A7-74726EDDDA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8063543-00C5-F06C-F901-5F4736FF8D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C0C0D54-E11D-2100-1082-390CCB3AA1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E928D9F-4A3F-A193-0356-3A7FFD0CC6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58EDF2B-B3F8-7088-D440-177F6F0032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33543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BE370C3-7288-E156-4CDA-CD12C7B7C4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39AC83A-CCD3-CF9B-0842-9FA65EA0DDE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02069E7-CE31-B14E-8F15-725348EE97B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3FF16AE-8A3E-46D7-ACD5-60223AAA50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60D6DD9-DFA9-DB84-AD1D-6D81E16B29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B0F7F54-6ABD-98FB-EBEE-BBAB12978F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61848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470DA7C-2594-6C9F-015A-D96E96EA4C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307476A-37D1-F63A-B228-1803DD9C1D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7329D0D-3C75-C050-9AA8-046501921D9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3396B8A3-F18B-FA21-3E7F-55B7CE264E4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795F0172-07E9-1BD1-4BE6-274DF4C4684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EA39993C-D8A7-86A7-419D-8CC9B9B90F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3C920688-ABFA-3F8E-4ECA-27A58870F7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0B328E0D-17D3-AA06-0F66-9FA3D9AB38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65123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1E4B0CF-A5B3-0B82-2CEC-39CDF30623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365D74F-64C2-A671-482B-553D8D371A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0C484A4E-E892-278F-9ABA-B3B7D642E2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1D527508-3A04-46BC-638E-1CF59DEB11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26251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CD4C87BA-3A7F-83B6-2763-7F44FCED2A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2EBF0517-E863-0C9E-AD5A-97E1DEB506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A8E4E00F-1C47-9276-6B92-1112BD1691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89904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7E253E4-B1B1-3DB8-F98E-67A83577DB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33D5132-A9BE-D52F-5E9A-44869C6CFA6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7E9A37D-6D13-4556-5993-EFD57CF2A97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0E6028F-C45A-C768-F3DF-1A3EBCE3AD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C257CB5-2ED2-E0FF-A6D9-11B1DEE2C6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816789D-CD1A-4DE9-5261-9B76E5A47E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54505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ADCE48B-160C-A889-6685-7D50FCE3F8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ACD3D4F2-8379-7544-D556-9158BA6C169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EBE937E-A323-8E2F-91B8-6B6A2197C12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4343373-95E2-E9CA-DE03-BDF23F65BD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0194E29-7F03-0BF8-973F-56C22C696C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416E4EE-F028-D2C6-7702-24616E6747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76976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BE57FFD-B15E-6F48-E2AA-38710242DE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6D1A6F5-FCEB-53E1-DA29-F7D97EA11E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73D23F2-F598-4B43-7FAD-03E8CE7147C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23A2A1F-FDBB-B79D-0684-734F8655BF6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2495D6E-2C5B-2860-08A9-652075FE37F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17403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37389BD-4698-EB23-0250-4DB6A54B55A9}"/>
              </a:ext>
            </a:extLst>
          </p:cNvPr>
          <p:cNvSpPr txBox="1"/>
          <p:nvPr/>
        </p:nvSpPr>
        <p:spPr>
          <a:xfrm>
            <a:off x="5529178" y="5364469"/>
            <a:ext cx="1133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fecture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3923B83-0867-ED70-647D-F3862EC952AE}"/>
              </a:ext>
            </a:extLst>
          </p:cNvPr>
          <p:cNvSpPr txBox="1"/>
          <p:nvPr/>
        </p:nvSpPr>
        <p:spPr>
          <a:xfrm>
            <a:off x="14088" y="2265184"/>
            <a:ext cx="1381524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 capita prefectural income (1,000 JPY)</a:t>
            </a:r>
            <a:endParaRPr lang="ja-JP" altLang="en-US" dirty="0"/>
          </a:p>
        </p:txBody>
      </p:sp>
      <p:cxnSp>
        <p:nvCxnSpPr>
          <p:cNvPr id="3" name="直線コネクタ 2">
            <a:extLst>
              <a:ext uri="{FF2B5EF4-FFF2-40B4-BE49-F238E27FC236}">
                <a16:creationId xmlns:a16="http://schemas.microsoft.com/office/drawing/2014/main" id="{EFB99EDC-A87A-41DA-35B6-DBB01FD0A404}"/>
              </a:ext>
            </a:extLst>
          </p:cNvPr>
          <p:cNvCxnSpPr>
            <a:cxnSpLocks/>
          </p:cNvCxnSpPr>
          <p:nvPr/>
        </p:nvCxnSpPr>
        <p:spPr>
          <a:xfrm>
            <a:off x="1742869" y="37608"/>
            <a:ext cx="18853" cy="491654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DEE362E1-2E56-2652-4668-B989AA1C817E}"/>
              </a:ext>
            </a:extLst>
          </p:cNvPr>
          <p:cNvCxnSpPr>
            <a:cxnSpLocks/>
          </p:cNvCxnSpPr>
          <p:nvPr/>
        </p:nvCxnSpPr>
        <p:spPr>
          <a:xfrm flipH="1">
            <a:off x="1740718" y="4944826"/>
            <a:ext cx="1016553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2EF1B8D6-FAAE-33D1-58E2-DB9D5493F4C5}"/>
              </a:ext>
            </a:extLst>
          </p:cNvPr>
          <p:cNvGraphicFramePr>
            <a:graphicFrameLocks/>
          </p:cNvGraphicFramePr>
          <p:nvPr/>
        </p:nvGraphicFramePr>
        <p:xfrm>
          <a:off x="1047553" y="390527"/>
          <a:ext cx="11002357" cy="53673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3BBB870-E6FF-2E6E-6160-90E995558C72}"/>
              </a:ext>
            </a:extLst>
          </p:cNvPr>
          <p:cNvSpPr txBox="1"/>
          <p:nvPr/>
        </p:nvSpPr>
        <p:spPr>
          <a:xfrm>
            <a:off x="331695" y="6177180"/>
            <a:ext cx="1151481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. The prefectural income trend among prefectures in Japan between 2016 to 2018</a:t>
            </a:r>
            <a:endParaRPr lang="ja-JP" altLang="en-US" sz="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ja-JP">
                <a:latin typeface="Times New Roman" panose="02020603050405020304" pitchFamily="18" charset="0"/>
                <a:cs typeface="Times New Roman" panose="02020603050405020304" pitchFamily="18" charset="0"/>
              </a:rPr>
              <a:t>legends: A figure shows the per capita prefectural income trends in each prefecture between 2016 and 2018.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340943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4</Words>
  <Application>Microsoft Office PowerPoint</Application>
  <PresentationFormat>ワイド画面</PresentationFormat>
  <Paragraphs>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本貴文</dc:creator>
  <cp:lastModifiedBy>takafumi yamamoto</cp:lastModifiedBy>
  <cp:revision>7</cp:revision>
  <dcterms:created xsi:type="dcterms:W3CDTF">2023-12-07T06:34:18Z</dcterms:created>
  <dcterms:modified xsi:type="dcterms:W3CDTF">2024-02-12T23:20:40Z</dcterms:modified>
</cp:coreProperties>
</file>